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56" r:id="rId2"/>
    <p:sldId id="260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588"/>
    <p:restoredTop sz="86442"/>
  </p:normalViewPr>
  <p:slideViewPr>
    <p:cSldViewPr snapToGrid="0" snapToObjects="1">
      <p:cViewPr>
        <p:scale>
          <a:sx n="100" d="100"/>
          <a:sy n="100" d="100"/>
        </p:scale>
        <p:origin x="-80" y="-80"/>
      </p:cViewPr>
      <p:guideLst>
        <p:guide orient="horz" pos="2160"/>
        <p:guide pos="4296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5121D8-7434-8943-9FA3-C7FFC3853C58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9FF86D-3B0E-3644-A628-55750BCADE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8903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784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467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239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4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433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13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66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94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640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673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170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7FA98-5EF6-6745-AF17-113B4A88356A}" type="datetimeFigureOut">
              <a:rPr lang="en-US" smtClean="0"/>
              <a:t>13/1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BCED2-C3CA-FA4E-AB18-1F8C0813F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546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4" Type="http://schemas.microsoft.com/office/2007/relationships/hdphoto" Target="../media/hdphoto1.wdp"/><Relationship Id="rId5" Type="http://schemas.openxmlformats.org/officeDocument/2006/relationships/image" Target="../media/image7.jpeg"/><Relationship Id="rId6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09223" y="68402"/>
            <a:ext cx="7232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>
                <a:latin typeface="Arial" charset="0"/>
                <a:ea typeface="Arial" charset="0"/>
                <a:cs typeface="Arial" charset="0"/>
              </a:rPr>
              <a:t>Fig 1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310996" y="34461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9670" y="2632463"/>
            <a:ext cx="1058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nti-JARID2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3212" y="4137758"/>
            <a:ext cx="10580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nti-GAPDH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883110" y="2416131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charset="0"/>
                <a:ea typeface="Arial" charset="0"/>
                <a:cs typeface="Arial" charset="0"/>
              </a:rPr>
              <a:t>25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39565" y="2686098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charset="0"/>
                <a:ea typeface="Arial" charset="0"/>
                <a:cs typeface="Arial" charset="0"/>
              </a:rPr>
              <a:t>13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48272" y="2982191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>
                <a:latin typeface="Arial" charset="0"/>
                <a:ea typeface="Arial" charset="0"/>
                <a:cs typeface="Arial" charset="0"/>
              </a:rPr>
              <a:t>100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30853" y="3278284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70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26497" y="3522125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charset="0"/>
                <a:ea typeface="Arial" charset="0"/>
                <a:cs typeface="Arial" charset="0"/>
              </a:rPr>
              <a:t>55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822141" y="4170916"/>
            <a:ext cx="5189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>
                <a:latin typeface="Arial" charset="0"/>
                <a:ea typeface="Arial" charset="0"/>
                <a:cs typeface="Arial" charset="0"/>
              </a:rPr>
              <a:t>35</a:t>
            </a:r>
          </a:p>
        </p:txBody>
      </p:sp>
      <p:grpSp>
        <p:nvGrpSpPr>
          <p:cNvPr id="16" name="Group 15"/>
          <p:cNvGrpSpPr/>
          <p:nvPr/>
        </p:nvGrpSpPr>
        <p:grpSpPr>
          <a:xfrm>
            <a:off x="1311581" y="1164109"/>
            <a:ext cx="1439285" cy="3787705"/>
            <a:chOff x="1311581" y="562225"/>
            <a:chExt cx="1293685" cy="378770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00"/>
            <a:stretch/>
          </p:blipFill>
          <p:spPr>
            <a:xfrm>
              <a:off x="1311581" y="1592166"/>
              <a:ext cx="1293685" cy="275776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 rot="18179452">
              <a:off x="1152423" y="966783"/>
              <a:ext cx="1058093" cy="2489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>
                  <a:latin typeface="Arial" charset="0"/>
                  <a:ea typeface="Arial" charset="0"/>
                  <a:cs typeface="Arial" charset="0"/>
                </a:rPr>
                <a:t>Marker </a:t>
              </a:r>
              <a:endParaRPr lang="en-US" sz="12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 rot="18264455">
              <a:off x="1594456" y="1150760"/>
              <a:ext cx="734275" cy="2351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/>
                  <a:cs typeface="Arial"/>
                </a:rPr>
                <a:t>hESC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8264455">
              <a:off x="2036582" y="1122335"/>
              <a:ext cx="734275" cy="23514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/>
                  <a:cs typeface="Arial"/>
                </a:rPr>
                <a:t>mESC</a:t>
              </a:r>
              <a:endParaRPr lang="en-US" sz="1100" dirty="0">
                <a:latin typeface="Arial"/>
                <a:cs typeface="Arial"/>
              </a:endParaRPr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2750866" y="1321496"/>
            <a:ext cx="1876246" cy="3662931"/>
            <a:chOff x="2797360" y="1496066"/>
            <a:chExt cx="1876246" cy="3218115"/>
          </a:xfrm>
        </p:grpSpPr>
        <p:grpSp>
          <p:nvGrpSpPr>
            <p:cNvPr id="19" name="Group 18"/>
            <p:cNvGrpSpPr/>
            <p:nvPr/>
          </p:nvGrpSpPr>
          <p:grpSpPr>
            <a:xfrm>
              <a:off x="2797360" y="2309208"/>
              <a:ext cx="1876246" cy="2404973"/>
              <a:chOff x="3011991" y="1684175"/>
              <a:chExt cx="1876246" cy="2404973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011991" y="1684175"/>
                <a:ext cx="1876246" cy="1291486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463" b="17328"/>
              <a:stretch/>
            </p:blipFill>
            <p:spPr>
              <a:xfrm>
                <a:off x="3042041" y="3020744"/>
                <a:ext cx="1822530" cy="1068404"/>
              </a:xfrm>
              <a:prstGeom prst="rect">
                <a:avLst/>
              </a:prstGeom>
            </p:spPr>
          </p:pic>
        </p:grpSp>
        <p:sp>
          <p:nvSpPr>
            <p:cNvPr id="20" name="TextBox 19"/>
            <p:cNvSpPr txBox="1"/>
            <p:nvPr/>
          </p:nvSpPr>
          <p:spPr>
            <a:xfrm rot="18477843">
              <a:off x="3288476" y="1739598"/>
              <a:ext cx="748673" cy="261610"/>
            </a:xfrm>
            <a:prstGeom prst="rect">
              <a:avLst/>
            </a:prstGeom>
            <a:noFill/>
          </p:spPr>
          <p:txBody>
            <a:bodyPr wrap="none" lIns="0" rtlCol="0">
              <a:spAutoFit/>
            </a:bodyPr>
            <a:lstStyle/>
            <a:p>
              <a:pPr algn="ctr"/>
              <a:r>
                <a:rPr lang="en-US" sz="1100" dirty="0">
                  <a:latin typeface="Arial" charset="0"/>
                  <a:ea typeface="Arial" charset="0"/>
                  <a:cs typeface="Arial" charset="0"/>
                </a:rPr>
                <a:t>Lymphocyte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8394863">
              <a:off x="3720004" y="1873758"/>
              <a:ext cx="517707" cy="215444"/>
            </a:xfrm>
            <a:prstGeom prst="rect">
              <a:avLst/>
            </a:prstGeom>
            <a:noFill/>
          </p:spPr>
          <p:txBody>
            <a:bodyPr wrap="none" lIns="0" tIns="0" rtlCol="0">
              <a:spAutoFit/>
            </a:bodyPr>
            <a:lstStyle/>
            <a:p>
              <a:pPr algn="ctr"/>
              <a:r>
                <a:rPr lang="en-US" sz="1100" dirty="0">
                  <a:latin typeface="Arial" charset="0"/>
                  <a:ea typeface="Arial" charset="0"/>
                  <a:cs typeface="Arial" charset="0"/>
                </a:rPr>
                <a:t>HUVEC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 rot="18309544">
              <a:off x="4073646" y="1870204"/>
              <a:ext cx="337439" cy="261610"/>
            </a:xfrm>
            <a:prstGeom prst="rect">
              <a:avLst/>
            </a:prstGeom>
            <a:noFill/>
          </p:spPr>
          <p:txBody>
            <a:bodyPr wrap="none" lIns="0" rtlCol="0">
              <a:spAutoFit/>
            </a:bodyPr>
            <a:lstStyle/>
            <a:p>
              <a:pPr algn="ctr"/>
              <a:r>
                <a:rPr lang="en-US" sz="1100" dirty="0">
                  <a:latin typeface="Arial" charset="0"/>
                  <a:ea typeface="Arial" charset="0"/>
                  <a:cs typeface="Arial" charset="0"/>
                </a:rPr>
                <a:t>HEK</a:t>
              </a: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1966446" y="950063"/>
            <a:ext cx="53572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u="sng" dirty="0">
                <a:latin typeface="Arial"/>
                <a:cs typeface="Arial"/>
              </a:rPr>
              <a:t>Stem</a:t>
            </a:r>
          </a:p>
          <a:p>
            <a:r>
              <a:rPr lang="en-US" sz="1100" b="1" u="sng" dirty="0">
                <a:latin typeface="Arial"/>
                <a:cs typeface="Arial"/>
              </a:rPr>
              <a:t> cell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621234" y="939131"/>
            <a:ext cx="74732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u="sng" dirty="0">
                <a:latin typeface="Arial"/>
                <a:cs typeface="Arial"/>
              </a:rPr>
              <a:t>Primary </a:t>
            </a:r>
          </a:p>
          <a:p>
            <a:pPr algn="ctr"/>
            <a:r>
              <a:rPr lang="en-US" sz="1100" b="1" u="sng" dirty="0">
                <a:latin typeface="Arial"/>
                <a:cs typeface="Arial"/>
              </a:rPr>
              <a:t>cells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25"/>
          <a:stretch/>
        </p:blipFill>
        <p:spPr>
          <a:xfrm>
            <a:off x="4680753" y="2217463"/>
            <a:ext cx="2528602" cy="3294337"/>
          </a:xfrm>
          <a:prstGeom prst="rect">
            <a:avLst/>
          </a:prstGeom>
        </p:spPr>
      </p:pic>
      <p:grpSp>
        <p:nvGrpSpPr>
          <p:cNvPr id="25" name="Group 24"/>
          <p:cNvGrpSpPr/>
          <p:nvPr/>
        </p:nvGrpSpPr>
        <p:grpSpPr>
          <a:xfrm>
            <a:off x="5022881" y="1049728"/>
            <a:ext cx="2157798" cy="1185210"/>
            <a:chOff x="2964600" y="1409632"/>
            <a:chExt cx="2280954" cy="1376772"/>
          </a:xfrm>
        </p:grpSpPr>
        <p:sp>
          <p:nvSpPr>
            <p:cNvPr id="37" name="TextBox 36"/>
            <p:cNvSpPr txBox="1"/>
            <p:nvPr/>
          </p:nvSpPr>
          <p:spPr>
            <a:xfrm rot="18264455">
              <a:off x="2676394" y="2202827"/>
              <a:ext cx="852954" cy="276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/>
                  <a:cs typeface="Arial"/>
                </a:rPr>
                <a:t>HEK293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 rot="18352891">
              <a:off x="3012722" y="2191308"/>
              <a:ext cx="823891" cy="276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/>
                  <a:cs typeface="Arial"/>
                </a:rPr>
                <a:t>HaCaT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8330039">
              <a:off x="3480944" y="2231066"/>
              <a:ext cx="691143" cy="276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Arial"/>
                  <a:cs typeface="Arial"/>
                </a:rPr>
                <a:t>Hela</a:t>
              </a:r>
              <a:endParaRPr lang="en-US" sz="1100" dirty="0">
                <a:latin typeface="Arial"/>
                <a:cs typeface="Arial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8330322">
              <a:off x="3657248" y="1959747"/>
              <a:ext cx="1376772" cy="276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/>
                  <a:cs typeface="Arial"/>
                </a:rPr>
                <a:t>MDA-MB231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 rot="18263616">
              <a:off x="4086998" y="2186527"/>
              <a:ext cx="839687" cy="276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/>
                  <a:cs typeface="Arial"/>
                </a:rPr>
                <a:t>A549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 rot="18235984">
              <a:off x="4454026" y="2224496"/>
              <a:ext cx="760152" cy="2765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/>
                  <a:cs typeface="Arial"/>
                </a:rPr>
                <a:t>HepG2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 rot="18299025">
              <a:off x="4780810" y="2234613"/>
              <a:ext cx="652948" cy="2765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latin typeface="Arial"/>
                  <a:cs typeface="Arial"/>
                </a:rPr>
                <a:t>K562</a:t>
              </a: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6453025" y="935803"/>
            <a:ext cx="824265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u="sng" dirty="0">
                <a:latin typeface="Arial"/>
                <a:cs typeface="Arial"/>
              </a:rPr>
              <a:t>Cancer</a:t>
            </a:r>
          </a:p>
          <a:p>
            <a:pPr algn="ctr"/>
            <a:r>
              <a:rPr lang="en-US" sz="1100" b="1" u="sng" dirty="0">
                <a:latin typeface="Arial"/>
                <a:cs typeface="Arial"/>
              </a:rPr>
              <a:t> cell-lines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184027" y="968604"/>
            <a:ext cx="962123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u="sng" dirty="0">
                <a:latin typeface="Arial"/>
                <a:cs typeface="Arial"/>
              </a:rPr>
              <a:t>Non-cancer</a:t>
            </a:r>
          </a:p>
          <a:p>
            <a:pPr algn="ctr"/>
            <a:r>
              <a:rPr lang="en-US" sz="1100" b="1" u="sng" dirty="0">
                <a:latin typeface="Arial"/>
                <a:cs typeface="Arial"/>
              </a:rPr>
              <a:t>cell-lines</a:t>
            </a:r>
          </a:p>
        </p:txBody>
      </p:sp>
    </p:spTree>
    <p:extLst>
      <p:ext uri="{BB962C8B-B14F-4D97-AF65-F5344CB8AC3E}">
        <p14:creationId xmlns:p14="http://schemas.microsoft.com/office/powerpoint/2010/main" val="1539270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11200" y="635000"/>
            <a:ext cx="864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/>
                <a:cs typeface="Arial"/>
              </a:rPr>
              <a:t>Fig 1C</a:t>
            </a:r>
            <a:endParaRPr lang="en-US" dirty="0">
              <a:latin typeface="Arial"/>
              <a:cs typeface="Arial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1607477"/>
              </p:ext>
            </p:extLst>
          </p:nvPr>
        </p:nvGraphicFramePr>
        <p:xfrm>
          <a:off x="711200" y="1282700"/>
          <a:ext cx="10922004" cy="233679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10167"/>
                <a:gridCol w="910167"/>
                <a:gridCol w="910167"/>
                <a:gridCol w="910167"/>
                <a:gridCol w="910167"/>
                <a:gridCol w="910167"/>
                <a:gridCol w="910167"/>
                <a:gridCol w="910167"/>
                <a:gridCol w="910167"/>
                <a:gridCol w="910167"/>
                <a:gridCol w="910167"/>
                <a:gridCol w="910167"/>
              </a:tblGrid>
              <a:tr h="705261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S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HEK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ymphocyte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UVEC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K-293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aCaT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la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DA-MB231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549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pG2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562</a:t>
                      </a:r>
                    </a:p>
                  </a:txBody>
                  <a:tcPr marL="12285" marR="12285" marT="12285" marB="0" anchor="b"/>
                </a:tc>
              </a:tr>
              <a:tr h="54384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1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456445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5233269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335059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09762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107811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545082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9123836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993662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659842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170026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170026</a:t>
                      </a:r>
                    </a:p>
                  </a:txBody>
                  <a:tcPr marL="12285" marR="12285" marT="12285" marB="0" anchor="b"/>
                </a:tc>
              </a:tr>
              <a:tr h="54384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2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1890958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6354208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716486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354455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604571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818454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7428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797967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3327363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4513915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1471933</a:t>
                      </a:r>
                    </a:p>
                  </a:txBody>
                  <a:tcPr marL="12285" marR="12285" marT="12285" marB="0" anchor="b"/>
                </a:tc>
              </a:tr>
              <a:tr h="54384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ep3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7299069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215623</a:t>
                      </a: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285" marR="12285" marT="1228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863367</a:t>
                      </a:r>
                    </a:p>
                  </a:txBody>
                  <a:tcPr marL="12285" marR="12285" marT="1228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442815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94275" y="715674"/>
            <a:ext cx="466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D</a:t>
            </a:r>
          </a:p>
        </p:txBody>
      </p:sp>
      <p:grpSp>
        <p:nvGrpSpPr>
          <p:cNvPr id="5" name="Group 4"/>
          <p:cNvGrpSpPr/>
          <p:nvPr/>
        </p:nvGrpSpPr>
        <p:grpSpPr>
          <a:xfrm>
            <a:off x="-269284" y="346088"/>
            <a:ext cx="4856843" cy="4010012"/>
            <a:chOff x="7188973" y="36042"/>
            <a:chExt cx="4223800" cy="3368486"/>
          </a:xfrm>
        </p:grpSpPr>
        <p:grpSp>
          <p:nvGrpSpPr>
            <p:cNvPr id="6" name="Group 5"/>
            <p:cNvGrpSpPr/>
            <p:nvPr/>
          </p:nvGrpSpPr>
          <p:grpSpPr>
            <a:xfrm>
              <a:off x="7188973" y="36042"/>
              <a:ext cx="4006913" cy="3030236"/>
              <a:chOff x="7188973" y="36042"/>
              <a:chExt cx="4006913" cy="3030236"/>
            </a:xfrm>
          </p:grpSpPr>
          <p:sp>
            <p:nvSpPr>
              <p:cNvPr id="9" name="TextBox 8"/>
              <p:cNvSpPr txBox="1"/>
              <p:nvPr/>
            </p:nvSpPr>
            <p:spPr>
              <a:xfrm rot="18002213">
                <a:off x="10189958" y="537617"/>
                <a:ext cx="1181421" cy="2616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siRNA1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 rot="18000381">
                <a:off x="10474370" y="495947"/>
                <a:ext cx="1181421" cy="26161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/>
                    <a:cs typeface="Arial"/>
                  </a:rPr>
                  <a:t>siRNA2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8179452">
                <a:off x="8452165" y="572177"/>
                <a:ext cx="10580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>
                    <a:latin typeface="Arial" charset="0"/>
                    <a:ea typeface="Arial" charset="0"/>
                    <a:cs typeface="Arial" charset="0"/>
                  </a:rPr>
                  <a:t>Marker </a:t>
                </a:r>
                <a:endParaRPr lang="en-US" sz="12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12" name="Group 11"/>
              <p:cNvGrpSpPr/>
              <p:nvPr/>
            </p:nvGrpSpPr>
            <p:grpSpPr>
              <a:xfrm>
                <a:off x="7188973" y="328725"/>
                <a:ext cx="3313816" cy="2737553"/>
                <a:chOff x="7188973" y="328725"/>
                <a:chExt cx="3313816" cy="2737553"/>
              </a:xfrm>
            </p:grpSpPr>
            <p:sp>
              <p:nvSpPr>
                <p:cNvPr id="13" name="TextBox 12"/>
                <p:cNvSpPr txBox="1"/>
                <p:nvPr/>
              </p:nvSpPr>
              <p:spPr>
                <a:xfrm rot="17627890">
                  <a:off x="10034626" y="746357"/>
                  <a:ext cx="674716" cy="2616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/>
                      <a:cs typeface="Arial"/>
                    </a:rPr>
                    <a:t>Ctrl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7238749" y="2666168"/>
                  <a:ext cx="1181133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/>
                      <a:cs typeface="Arial"/>
                    </a:rPr>
                    <a:t>a</a:t>
                  </a:r>
                  <a:r>
                    <a:rPr lang="en-US" sz="1200" dirty="0" smtClean="0">
                      <a:latin typeface="Arial"/>
                      <a:cs typeface="Arial"/>
                    </a:rPr>
                    <a:t>nti-GAPDH</a:t>
                  </a:r>
                  <a:endParaRPr lang="en-US" sz="1200" dirty="0">
                    <a:latin typeface="Arial"/>
                    <a:cs typeface="Arial"/>
                  </a:endParaRPr>
                </a:p>
                <a:p>
                  <a:pPr algn="ctr"/>
                  <a:r>
                    <a:rPr lang="en-US" sz="1200" dirty="0" smtClean="0">
                      <a:latin typeface="Arial"/>
                      <a:cs typeface="Arial"/>
                    </a:rPr>
                    <a:t>  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7188973" y="1920768"/>
                  <a:ext cx="1230908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/>
                      <a:cs typeface="Arial"/>
                    </a:rPr>
                    <a:t>a</a:t>
                  </a:r>
                  <a:r>
                    <a:rPr lang="en-US" sz="1200" dirty="0" smtClean="0">
                      <a:latin typeface="Arial"/>
                      <a:cs typeface="Arial"/>
                    </a:rPr>
                    <a:t>nti-JARID2</a:t>
                  </a:r>
                  <a:endParaRPr lang="en-US" sz="1200" dirty="0">
                    <a:latin typeface="Arial"/>
                    <a:cs typeface="Arial"/>
                  </a:endParaRPr>
                </a:p>
                <a:p>
                  <a:pPr algn="ctr"/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9705631" y="328725"/>
                  <a:ext cx="67037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 err="1">
                      <a:latin typeface="Arial"/>
                      <a:cs typeface="Arial"/>
                    </a:rPr>
                    <a:t>HaCaT</a:t>
                  </a:r>
                  <a:endParaRPr lang="en-US" sz="12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" name="Rectangle 16"/>
                <p:cNvSpPr/>
                <p:nvPr/>
              </p:nvSpPr>
              <p:spPr>
                <a:xfrm>
                  <a:off x="9501436" y="1575007"/>
                  <a:ext cx="859358" cy="1351459"/>
                </a:xfrm>
                <a:prstGeom prst="rect">
                  <a:avLst/>
                </a:prstGeom>
                <a:noFill/>
                <a:ln w="19050">
                  <a:solidFill>
                    <a:srgbClr val="FFFF0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8216494" y="1402460"/>
                  <a:ext cx="51898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charset="0"/>
                      <a:ea typeface="Arial" charset="0"/>
                      <a:cs typeface="Arial" charset="0"/>
                    </a:rPr>
                    <a:t>250</a:t>
                  </a: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8172949" y="1672427"/>
                  <a:ext cx="51898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charset="0"/>
                      <a:ea typeface="Arial" charset="0"/>
                      <a:cs typeface="Arial" charset="0"/>
                    </a:rPr>
                    <a:t>130</a:t>
                  </a: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8181656" y="1968520"/>
                  <a:ext cx="51898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>
                      <a:latin typeface="Arial" charset="0"/>
                      <a:ea typeface="Arial" charset="0"/>
                      <a:cs typeface="Arial" charset="0"/>
                    </a:rPr>
                    <a:t>100</a:t>
                  </a:r>
                  <a:endParaRPr lang="en-US" sz="1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8181015" y="2155556"/>
                  <a:ext cx="51898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 smtClean="0">
                      <a:latin typeface="Arial" charset="0"/>
                      <a:ea typeface="Arial" charset="0"/>
                      <a:cs typeface="Arial" charset="0"/>
                    </a:rPr>
                    <a:t>70</a:t>
                  </a:r>
                  <a:endParaRPr lang="en-US" sz="1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8168270" y="2382619"/>
                  <a:ext cx="51898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charset="0"/>
                      <a:ea typeface="Arial" charset="0"/>
                      <a:cs typeface="Arial" charset="0"/>
                    </a:rPr>
                    <a:t>55</a:t>
                  </a: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8180692" y="2788129"/>
                  <a:ext cx="518983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charset="0"/>
                      <a:ea typeface="Arial" charset="0"/>
                      <a:cs typeface="Arial" charset="0"/>
                    </a:rPr>
                    <a:t>35</a:t>
                  </a:r>
                </a:p>
              </p:txBody>
            </p:sp>
          </p:grpSp>
        </p:grpSp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55444">
              <a:off x="8648396" y="1125327"/>
              <a:ext cx="2764377" cy="2279201"/>
            </a:xfrm>
            <a:prstGeom prst="rect">
              <a:avLst/>
            </a:prstGeom>
          </p:spPr>
        </p:pic>
        <p:sp>
          <p:nvSpPr>
            <p:cNvPr id="8" name="Rectangle 7"/>
            <p:cNvSpPr/>
            <p:nvPr/>
          </p:nvSpPr>
          <p:spPr>
            <a:xfrm>
              <a:off x="10181866" y="1648680"/>
              <a:ext cx="862372" cy="733939"/>
            </a:xfrm>
            <a:prstGeom prst="rect">
              <a:avLst/>
            </a:prstGeom>
            <a:noFill/>
            <a:ln w="1905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5862721" y="908756"/>
            <a:ext cx="4114617" cy="3902740"/>
            <a:chOff x="1176421" y="-134794"/>
            <a:chExt cx="4114617" cy="3902740"/>
          </a:xfrm>
        </p:grpSpPr>
        <p:grpSp>
          <p:nvGrpSpPr>
            <p:cNvPr id="25" name="Group 24"/>
            <p:cNvGrpSpPr/>
            <p:nvPr/>
          </p:nvGrpSpPr>
          <p:grpSpPr>
            <a:xfrm>
              <a:off x="1176421" y="-134794"/>
              <a:ext cx="4114617" cy="3902740"/>
              <a:chOff x="-1574540" y="0"/>
              <a:chExt cx="12523528" cy="5770114"/>
            </a:xfrm>
          </p:grpSpPr>
          <p:sp>
            <p:nvSpPr>
              <p:cNvPr id="27" name="TextBox 26"/>
              <p:cNvSpPr txBox="1"/>
              <p:nvPr/>
            </p:nvSpPr>
            <p:spPr>
              <a:xfrm>
                <a:off x="0" y="0"/>
                <a:ext cx="695094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/>
                  <a:t>Figure 1.D</a:t>
                </a:r>
                <a:endParaRPr lang="en-US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5937661" y="369333"/>
                <a:ext cx="2591665" cy="6825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 smtClean="0">
                    <a:latin typeface="Arial" charset="0"/>
                    <a:ea typeface="Arial" charset="0"/>
                    <a:cs typeface="Arial" charset="0"/>
                  </a:rPr>
                  <a:t>HEK293</a:t>
                </a:r>
              </a:p>
              <a:p>
                <a:pPr algn="ctr"/>
                <a:endParaRPr lang="en-US" sz="1200" b="1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grpSp>
            <p:nvGrpSpPr>
              <p:cNvPr id="29" name="Group 28"/>
              <p:cNvGrpSpPr/>
              <p:nvPr/>
            </p:nvGrpSpPr>
            <p:grpSpPr>
              <a:xfrm>
                <a:off x="-1574540" y="892890"/>
                <a:ext cx="12523528" cy="4877224"/>
                <a:chOff x="-1180907" y="892889"/>
                <a:chExt cx="9392648" cy="4877224"/>
              </a:xfrm>
            </p:grpSpPr>
            <p:grpSp>
              <p:nvGrpSpPr>
                <p:cNvPr id="30" name="Group 29"/>
                <p:cNvGrpSpPr/>
                <p:nvPr/>
              </p:nvGrpSpPr>
              <p:grpSpPr>
                <a:xfrm>
                  <a:off x="1264446" y="1475240"/>
                  <a:ext cx="6947295" cy="4238981"/>
                  <a:chOff x="1264446" y="1045740"/>
                  <a:chExt cx="6947295" cy="4238981"/>
                </a:xfrm>
              </p:grpSpPr>
              <p:pic>
                <p:nvPicPr>
                  <p:cNvPr id="44" name="Picture 43"/>
                  <p:cNvPicPr>
                    <a:picLocks noChangeAspect="1"/>
                  </p:cNvPicPr>
                  <p:nvPr/>
                </p:nvPicPr>
                <p:blipFill rotWithShape="1">
                  <a:blip r:embed="rId3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brightnessContrast bright="22000" contrast="-21000"/>
                            </a14:imgEffect>
                          </a14:imgLayer>
                        </a14:imgProps>
                      </a:ext>
                    </a:extLst>
                  </a:blip>
                  <a:srcRect l="6092" t="21161" r="3082" b="11053"/>
                  <a:stretch/>
                </p:blipFill>
                <p:spPr>
                  <a:xfrm>
                    <a:off x="1264447" y="1045740"/>
                    <a:ext cx="6947294" cy="1718001"/>
                  </a:xfrm>
                  <a:prstGeom prst="rect">
                    <a:avLst/>
                  </a:prstGeom>
                </p:spPr>
              </p:pic>
              <p:pic>
                <p:nvPicPr>
                  <p:cNvPr id="45" name="Picture 44"/>
                  <p:cNvPicPr>
                    <a:picLocks noChangeAspect="1"/>
                  </p:cNvPicPr>
                  <p:nvPr/>
                </p:nvPicPr>
                <p:blipFill rotWithShape="1">
                  <a:blip r:embed="rId5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brightnessContrast bright="22000"/>
                            </a14:imgEffect>
                          </a14:imgLayer>
                        </a14:imgProps>
                      </a:ext>
                    </a:extLst>
                  </a:blip>
                  <a:srcRect l="8594" t="5911" r="1758" b="14298"/>
                  <a:stretch/>
                </p:blipFill>
                <p:spPr>
                  <a:xfrm>
                    <a:off x="1264446" y="2763741"/>
                    <a:ext cx="6947295" cy="2520980"/>
                  </a:xfrm>
                  <a:prstGeom prst="rect">
                    <a:avLst/>
                  </a:prstGeom>
                </p:spPr>
              </p:pic>
              <p:sp>
                <p:nvSpPr>
                  <p:cNvPr id="46" name="Rectangle 45"/>
                  <p:cNvSpPr/>
                  <p:nvPr/>
                </p:nvSpPr>
                <p:spPr>
                  <a:xfrm>
                    <a:off x="4121802" y="1104719"/>
                    <a:ext cx="2041120" cy="1563856"/>
                  </a:xfrm>
                  <a:prstGeom prst="rect">
                    <a:avLst/>
                  </a:prstGeom>
                  <a:noFill/>
                  <a:ln w="19050">
                    <a:solidFill>
                      <a:srgbClr val="FFFF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31" name="TextBox 30"/>
                <p:cNvSpPr txBox="1"/>
                <p:nvPr/>
              </p:nvSpPr>
              <p:spPr>
                <a:xfrm>
                  <a:off x="267399" y="1534221"/>
                  <a:ext cx="997048" cy="3110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 smtClean="0">
                      <a:latin typeface="Arial" charset="0"/>
                      <a:ea typeface="Arial" charset="0"/>
                      <a:cs typeface="Arial" charset="0"/>
                    </a:rPr>
                    <a:t>250</a:t>
                  </a:r>
                  <a:endParaRPr lang="en-US" sz="1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267399" y="1876951"/>
                  <a:ext cx="997048" cy="3110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 smtClean="0">
                      <a:latin typeface="Arial" charset="0"/>
                      <a:ea typeface="Arial" charset="0"/>
                      <a:cs typeface="Arial" charset="0"/>
                    </a:rPr>
                    <a:t>130</a:t>
                  </a:r>
                  <a:endParaRPr lang="en-US" sz="1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238408" y="2217651"/>
                  <a:ext cx="997049" cy="3110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 smtClean="0">
                      <a:latin typeface="Arial" charset="0"/>
                      <a:ea typeface="Arial" charset="0"/>
                      <a:cs typeface="Arial" charset="0"/>
                    </a:rPr>
                    <a:t>100</a:t>
                  </a:r>
                  <a:endParaRPr lang="en-US" sz="1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>
                <a:xfrm>
                  <a:off x="397764" y="2643417"/>
                  <a:ext cx="797726" cy="3110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 smtClean="0">
                      <a:latin typeface="Arial" charset="0"/>
                      <a:ea typeface="Arial" charset="0"/>
                      <a:cs typeface="Arial" charset="0"/>
                    </a:rPr>
                    <a:t>70</a:t>
                  </a:r>
                  <a:endParaRPr lang="en-US" sz="1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>
                <a:xfrm>
                  <a:off x="408739" y="3027123"/>
                  <a:ext cx="797726" cy="3110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 smtClean="0">
                      <a:latin typeface="Arial" charset="0"/>
                      <a:ea typeface="Arial" charset="0"/>
                      <a:cs typeface="Arial" charset="0"/>
                    </a:rPr>
                    <a:t>55</a:t>
                  </a:r>
                  <a:endParaRPr lang="en-US" sz="1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863273" y="5523892"/>
                  <a:ext cx="40117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1000" dirty="0" smtClean="0">
                      <a:latin typeface="Arial" charset="0"/>
                      <a:ea typeface="Arial" charset="0"/>
                      <a:cs typeface="Arial" charset="0"/>
                    </a:rPr>
                    <a:t>17</a:t>
                  </a:r>
                  <a:endParaRPr lang="en-US" sz="10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8" name="TextBox 37"/>
                <p:cNvSpPr txBox="1"/>
                <p:nvPr/>
              </p:nvSpPr>
              <p:spPr>
                <a:xfrm rot="19055990">
                  <a:off x="1248689" y="945682"/>
                  <a:ext cx="67253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 charset="0"/>
                      <a:ea typeface="Arial" charset="0"/>
                      <a:cs typeface="Arial" charset="0"/>
                    </a:rPr>
                    <a:t>    Marker          </a:t>
                  </a:r>
                  <a:endParaRPr lang="en-US" sz="12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39" name="TextBox 38"/>
                <p:cNvSpPr txBox="1"/>
                <p:nvPr/>
              </p:nvSpPr>
              <p:spPr>
                <a:xfrm>
                  <a:off x="-1180907" y="2169223"/>
                  <a:ext cx="1937538" cy="9555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charset="0"/>
                      <a:ea typeface="Arial" charset="0"/>
                      <a:cs typeface="Arial" charset="0"/>
                    </a:rPr>
                    <a:t>a</a:t>
                  </a:r>
                  <a:r>
                    <a:rPr lang="en-US" sz="1200" dirty="0" smtClean="0">
                      <a:latin typeface="Arial" charset="0"/>
                      <a:ea typeface="Arial" charset="0"/>
                      <a:cs typeface="Arial" charset="0"/>
                    </a:rPr>
                    <a:t>nti-JARID2</a:t>
                  </a:r>
                </a:p>
                <a:p>
                  <a:pPr algn="ctr"/>
                  <a:endParaRPr lang="en-US" sz="12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0" name="TextBox 39"/>
                <p:cNvSpPr txBox="1"/>
                <p:nvPr/>
              </p:nvSpPr>
              <p:spPr>
                <a:xfrm>
                  <a:off x="-1170226" y="3769810"/>
                  <a:ext cx="2041796" cy="9555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charset="0"/>
                      <a:ea typeface="Arial" charset="0"/>
                      <a:cs typeface="Arial" charset="0"/>
                    </a:rPr>
                    <a:t>a</a:t>
                  </a:r>
                  <a:r>
                    <a:rPr lang="en-US" sz="1200" dirty="0" smtClean="0">
                      <a:latin typeface="Arial" charset="0"/>
                      <a:ea typeface="Arial" charset="0"/>
                      <a:cs typeface="Arial" charset="0"/>
                    </a:rPr>
                    <a:t>nti-GAPDH </a:t>
                  </a:r>
                </a:p>
                <a:p>
                  <a:pPr algn="ctr"/>
                  <a:endParaRPr lang="en-US" sz="12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1" name="TextBox 40"/>
                <p:cNvSpPr txBox="1"/>
                <p:nvPr/>
              </p:nvSpPr>
              <p:spPr>
                <a:xfrm rot="19055990">
                  <a:off x="3911919" y="1050284"/>
                  <a:ext cx="1313465" cy="4095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 charset="0"/>
                      <a:ea typeface="Arial" charset="0"/>
                      <a:cs typeface="Arial" charset="0"/>
                    </a:rPr>
                    <a:t> Ctrl          </a:t>
                  </a:r>
                  <a:endParaRPr lang="en-US" sz="12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2" name="TextBox 41"/>
                <p:cNvSpPr txBox="1"/>
                <p:nvPr/>
              </p:nvSpPr>
              <p:spPr>
                <a:xfrm rot="19055990">
                  <a:off x="4551573" y="904555"/>
                  <a:ext cx="1802130" cy="4095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sz="1200" dirty="0" err="1" smtClean="0">
                      <a:latin typeface="Arial" charset="0"/>
                      <a:ea typeface="Arial" charset="0"/>
                      <a:cs typeface="Arial" charset="0"/>
                    </a:rPr>
                    <a:t>siRNA</a:t>
                  </a:r>
                  <a:r>
                    <a:rPr lang="en-US" sz="1200" dirty="0" smtClean="0">
                      <a:latin typeface="Arial" charset="0"/>
                      <a:ea typeface="Arial" charset="0"/>
                      <a:cs typeface="Arial" charset="0"/>
                    </a:rPr>
                    <a:t> 1          </a:t>
                  </a:r>
                  <a:endParaRPr lang="en-US" sz="12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>
                <a:xfrm rot="19055990">
                  <a:off x="5231774" y="892889"/>
                  <a:ext cx="1982544" cy="40953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 charset="0"/>
                      <a:ea typeface="Arial" charset="0"/>
                      <a:cs typeface="Arial" charset="0"/>
                    </a:rPr>
                    <a:t> </a:t>
                  </a:r>
                  <a:r>
                    <a:rPr lang="en-US" sz="1200" dirty="0" err="1" smtClean="0">
                      <a:latin typeface="Arial" charset="0"/>
                      <a:ea typeface="Arial" charset="0"/>
                      <a:cs typeface="Arial" charset="0"/>
                    </a:rPr>
                    <a:t>siRNA</a:t>
                  </a:r>
                  <a:r>
                    <a:rPr lang="en-US" sz="1200" dirty="0" smtClean="0">
                      <a:latin typeface="Arial" charset="0"/>
                      <a:ea typeface="Arial" charset="0"/>
                      <a:cs typeface="Arial" charset="0"/>
                    </a:rPr>
                    <a:t> 2          </a:t>
                  </a:r>
                  <a:endParaRPr lang="en-US" sz="1200" dirty="0">
                    <a:latin typeface="Arial" charset="0"/>
                    <a:ea typeface="Arial" charset="0"/>
                    <a:cs typeface="Arial" charset="0"/>
                  </a:endParaRPr>
                </a:p>
              </p:txBody>
            </p:sp>
          </p:grpSp>
        </p:grpSp>
        <p:sp>
          <p:nvSpPr>
            <p:cNvPr id="26" name="Rectangle 25"/>
            <p:cNvSpPr/>
            <p:nvPr/>
          </p:nvSpPr>
          <p:spPr>
            <a:xfrm>
              <a:off x="3486923" y="2414998"/>
              <a:ext cx="894149" cy="311312"/>
            </a:xfrm>
            <a:prstGeom prst="rect">
              <a:avLst/>
            </a:prstGeom>
            <a:noFill/>
            <a:ln w="19050"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8" name="TextBox 47"/>
          <p:cNvSpPr txBox="1"/>
          <p:nvPr/>
        </p:nvSpPr>
        <p:spPr>
          <a:xfrm>
            <a:off x="6559094" y="3489616"/>
            <a:ext cx="34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35</a:t>
            </a:r>
            <a:endParaRPr 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3172170" y="3613897"/>
            <a:ext cx="991620" cy="339534"/>
          </a:xfrm>
          <a:prstGeom prst="rect">
            <a:avLst/>
          </a:prstGeom>
          <a:noFill/>
          <a:ln w="1905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2208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4</TotalTime>
  <Words>138</Words>
  <Application>Microsoft Macintosh PowerPoint</Application>
  <PresentationFormat>Custom</PresentationFormat>
  <Paragraphs>10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a Al-Raawi</dc:creator>
  <cp:lastModifiedBy>Aditi Kanhere</cp:lastModifiedBy>
  <cp:revision>97</cp:revision>
  <dcterms:created xsi:type="dcterms:W3CDTF">2018-07-19T15:22:05Z</dcterms:created>
  <dcterms:modified xsi:type="dcterms:W3CDTF">2018-11-13T15:19:15Z</dcterms:modified>
</cp:coreProperties>
</file>